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00B4F-D262-4B4D-8FF0-4BAC617EA6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09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29920"/>
            <a:ext cx="77709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2FA4D-489A-476B-BDCB-69DACA2684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7760" y="198108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2992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7760" y="412992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ADBB0-94D1-47BC-8465-1098BF3188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00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440" y="1981080"/>
            <a:ext cx="250200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0720" y="1981080"/>
            <a:ext cx="250200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29920"/>
            <a:ext cx="250200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440" y="4129920"/>
            <a:ext cx="250200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0720" y="4129920"/>
            <a:ext cx="250200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72A9B-261B-4302-B094-3013CE93B5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0960" cy="4113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37AF5-7776-41CC-8978-71146E9410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09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78B51-68DB-45CD-92D3-F430DF5AC1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188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7760" y="1981080"/>
            <a:ext cx="379188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84987-B347-488D-9B1F-93FA945A52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DC075-475D-4D8D-B24A-324BEB4525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0960" cy="5292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FFD915-A498-46C0-9E18-A6FEAD0833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7760" y="1981080"/>
            <a:ext cx="379188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2992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66D3F-952E-42E6-870D-DD36582D23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188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7760" y="198108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7760" y="412992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9D45A-313E-4266-AEBF-425FA3B0CB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7760" y="1981080"/>
            <a:ext cx="379188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29920"/>
            <a:ext cx="7770960" cy="1962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C3DA3-4135-4670-91EB-6E536BF01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0960" cy="114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09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440" y="6248520"/>
            <a:ext cx="190332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3720" y="6248520"/>
            <a:ext cx="289404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368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23237F8E-CA15-4602-BF84-08C1E2EA4B6C}" type="slidenum"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62120" y="838080"/>
            <a:ext cx="7543800" cy="6040080"/>
            <a:chOff x="762120" y="838080"/>
            <a:chExt cx="7543800" cy="6040080"/>
          </a:xfrm>
        </p:grpSpPr>
        <p:sp>
          <p:nvSpPr>
            <p:cNvPr id="42" name=""/>
            <p:cNvSpPr/>
            <p:nvPr/>
          </p:nvSpPr>
          <p:spPr>
            <a:xfrm>
              <a:off x="1143000" y="990720"/>
              <a:ext cx="7086600" cy="5887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Health problems with their family member 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18 (40.9%)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Family lifecycle issues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10 (22.7%)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Aging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3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Going on to school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3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Family death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3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Childbirth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Work related issues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6 (13.7%)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Unemployment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3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Irregularity of work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Transfer of job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Overworking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Generational conflict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3 (6.8%)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Economic sufferings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2 (4.5%)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Others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	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5 (11.4%)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marL="457200" indent="-455760">
                <a:tabLst>
                  <a:tab algn="l" pos="0"/>
                  <a:tab algn="l" pos="45720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（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divorce, don’t want to answer, and so on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ＭＳ 明朝"/>
                </a:rPr>
                <a:t>）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762120" y="838080"/>
              <a:ext cx="7543800" cy="5791320"/>
            </a:xfrm>
            <a:prstGeom prst="rect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762120" y="1447920"/>
              <a:ext cx="75438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248520" y="838080"/>
              <a:ext cx="1440" cy="57913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62120" y="3352680"/>
              <a:ext cx="75438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62120" y="5181480"/>
              <a:ext cx="7543800" cy="180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828800" y="2057400"/>
              <a:ext cx="92160" cy="990720"/>
            </a:xfrm>
            <a:custGeom>
              <a:avLst/>
              <a:gdLst>
                <a:gd name="textAreaLeft" fmla="*/ 59040 w 92160"/>
                <a:gd name="textAreaRight" fmla="*/ 92520 w 92160"/>
                <a:gd name="textAreaTop" fmla="*/ 25560 h 990720"/>
                <a:gd name="textAreaBottom" fmla="*/ 965160 h 990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828800" y="3886200"/>
              <a:ext cx="92160" cy="990720"/>
            </a:xfrm>
            <a:custGeom>
              <a:avLst/>
              <a:gdLst>
                <a:gd name="textAreaLeft" fmla="*/ 59040 w 92160"/>
                <a:gd name="textAreaRight" fmla="*/ 92520 w 92160"/>
                <a:gd name="textAreaTop" fmla="*/ 25560 h 990720"/>
                <a:gd name="textAreaBottom" fmla="*/ 965160 h 990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09480" y="-92520"/>
            <a:ext cx="7772400" cy="94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</a:rPr>
              <a:t>Additional file 1: Table S1</a:t>
            </a:r>
            <a:r>
              <a:rPr b="1" lang="en-US" sz="2800" spc="-1" strike="noStrike">
                <a:solidFill>
                  <a:srgbClr val="000000"/>
                </a:solidFill>
                <a:latin typeface="Times New Roman"/>
              </a:rPr>
              <a:t>：</a:t>
            </a:r>
            <a:r>
              <a:rPr b="1" lang="en-US" sz="2800" spc="-1" strike="noStrike">
                <a:solidFill>
                  <a:srgbClr val="000000"/>
                </a:solidFill>
                <a:latin typeface="Times New Roman"/>
              </a:rPr>
              <a:t>Family issues with the diabetic patients</a:t>
            </a:r>
            <a:endParaRPr b="0" lang="en-US" sz="2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03-31T06:46:06Z</dcterms:created>
  <dc:creator>竹中裕昭</dc:creator>
  <dc:description/>
  <dc:language>en-US</dc:language>
  <cp:lastModifiedBy>竹中裕昭</cp:lastModifiedBy>
  <dcterms:modified xsi:type="dcterms:W3CDTF">2013-03-25T13:00:18Z</dcterms:modified>
  <cp:revision>187</cp:revision>
  <dc:subject/>
  <dc:title>PowerPoint プレゼンテーション</dc:title>
</cp:coreProperties>
</file>